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EBA273E-471C-4DED-8C2D-4E074A31101F}" v="3" dt="2025-01-08T16:59:13.507"/>
    <p1510:client id="{4E2359BF-C657-49FC-9F1B-174E4CD537C7}" v="4" dt="2025-01-09T13:25:43.416"/>
    <p1510:client id="{69CAFFFB-9650-48E2-AAE0-9BABD57BCD86}" v="3" dt="2025-01-08T17:13:33.76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1" autoAdjust="0"/>
    <p:restoredTop sz="94689"/>
  </p:normalViewPr>
  <p:slideViewPr>
    <p:cSldViewPr snapToGrid="0">
      <p:cViewPr varScale="1">
        <p:scale>
          <a:sx n="102" d="100"/>
          <a:sy n="102" d="100"/>
        </p:scale>
        <p:origin x="438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1734A-E652-448B-A236-1118FD978682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D79A3-8800-421A-89A0-1E6AE2865E0F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007043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1734A-E652-448B-A236-1118FD978682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D79A3-8800-421A-89A0-1E6AE2865E0F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0642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1734A-E652-448B-A236-1118FD978682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D79A3-8800-421A-89A0-1E6AE2865E0F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656036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1734A-E652-448B-A236-1118FD978682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D79A3-8800-421A-89A0-1E6AE2865E0F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350554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1734A-E652-448B-A236-1118FD978682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D79A3-8800-421A-89A0-1E6AE2865E0F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055345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1734A-E652-448B-A236-1118FD978682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D79A3-8800-421A-89A0-1E6AE2865E0F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345791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1734A-E652-448B-A236-1118FD978682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D79A3-8800-421A-89A0-1E6AE2865E0F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692680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1734A-E652-448B-A236-1118FD978682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D79A3-8800-421A-89A0-1E6AE2865E0F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1819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1734A-E652-448B-A236-1118FD978682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D79A3-8800-421A-89A0-1E6AE2865E0F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099876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1734A-E652-448B-A236-1118FD978682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D79A3-8800-421A-89A0-1E6AE2865E0F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13329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1734A-E652-448B-A236-1118FD978682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D79A3-8800-421A-89A0-1E6AE2865E0F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12060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AB1734A-E652-448B-A236-1118FD978682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3BD79A3-8800-421A-89A0-1E6AE2865E0F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11261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 7">
            <a:extLst>
              <a:ext uri="{FF2B5EF4-FFF2-40B4-BE49-F238E27FC236}">
                <a16:creationId xmlns:a16="http://schemas.microsoft.com/office/drawing/2014/main" id="{74A002C6-5E28-7619-7ABA-330709DF547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18123" y="948007"/>
            <a:ext cx="2880000" cy="1691429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47BDF155-9A30-2BAC-73CA-81E97E5D424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069" y="948007"/>
            <a:ext cx="2880000" cy="1691429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BD85AF30-1A05-B623-23AD-732C7F215B0A}"/>
              </a:ext>
            </a:extLst>
          </p:cNvPr>
          <p:cNvSpPr txBox="1"/>
          <p:nvPr/>
        </p:nvSpPr>
        <p:spPr>
          <a:xfrm>
            <a:off x="0" y="0"/>
            <a:ext cx="1093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igure S4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C733C013-6D4E-BA2A-13C2-67553F764129}"/>
              </a:ext>
            </a:extLst>
          </p:cNvPr>
          <p:cNvSpPr txBox="1"/>
          <p:nvPr/>
        </p:nvSpPr>
        <p:spPr>
          <a:xfrm>
            <a:off x="0" y="636953"/>
            <a:ext cx="391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.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63D31E6D-375C-36D2-E9A3-35BE3F848039}"/>
              </a:ext>
            </a:extLst>
          </p:cNvPr>
          <p:cNvSpPr txBox="1"/>
          <p:nvPr/>
        </p:nvSpPr>
        <p:spPr>
          <a:xfrm>
            <a:off x="3233466" y="636953"/>
            <a:ext cx="384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.</a:t>
            </a: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B0479AF4-2BF0-67A8-9BBD-A4E2BDD436AB}"/>
              </a:ext>
            </a:extLst>
          </p:cNvPr>
          <p:cNvSpPr txBox="1"/>
          <p:nvPr/>
        </p:nvSpPr>
        <p:spPr>
          <a:xfrm>
            <a:off x="391069" y="2750435"/>
            <a:ext cx="610705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>
                <a:latin typeface="Calibri" panose="020F0502020204030204" pitchFamily="34" charset="0"/>
                <a:cs typeface="Calibri" panose="020F0502020204030204" pitchFamily="34" charset="0"/>
              </a:rPr>
              <a:t>Figure S4. </a:t>
            </a:r>
            <a:r>
              <a:rPr lang="en-GB" sz="1000" dirty="0">
                <a:latin typeface="Calibri" panose="020F0502020204030204" pitchFamily="34" charset="0"/>
                <a:cs typeface="Calibri" panose="020F0502020204030204" pitchFamily="34" charset="0"/>
              </a:rPr>
              <a:t>Sensitivity analysis after censuring patients at allogeneic HSCT: A) Relapse-free survival (n=383), B) Cumulative incidence of relapse.</a:t>
            </a:r>
            <a:endParaRPr lang="es-FR" sz="1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531396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hèm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34</Words>
  <Application>Microsoft Macintosh PowerPoint</Application>
  <PresentationFormat>A4 (210 x 297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Thèm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Pierre-Yves Dumas</dc:creator>
  <cp:lastModifiedBy>Gaspar Aspas Requena</cp:lastModifiedBy>
  <cp:revision>2</cp:revision>
  <dcterms:created xsi:type="dcterms:W3CDTF">2025-01-07T17:58:59Z</dcterms:created>
  <dcterms:modified xsi:type="dcterms:W3CDTF">2025-09-06T07:38:22Z</dcterms:modified>
</cp:coreProperties>
</file>